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256A38-3824-4D4E-AF65-1CFCFB1307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E0A1B-1DCB-43FE-913F-C8513C2FF1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F53C59-D50A-416E-8C78-7A95ACC929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1B86A5-7669-42E0-BE9C-0CCB836DCB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90183B-3018-4FE3-8D0D-B790D0AC19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39E616-3395-4A3C-947E-6970B86523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0650A9-F358-4C87-B75B-C611C19885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A02D80-4D0A-4E58-B28E-C871E5ED2D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7D1FC9-8BED-4F7A-BA3D-A32D7CC51F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57601F-8AB2-4163-982A-2CDDAA6039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8293C9-182C-4278-BE5B-48FAF2AE88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999A3E-302A-4C4D-87C8-3B020954B2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D725E65-9BE1-4B87-8239-B5420980B43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1031760" y="204840"/>
            <a:ext cx="5826240" cy="5481720"/>
            <a:chOff x="1031760" y="204840"/>
            <a:chExt cx="5826240" cy="5481720"/>
          </a:xfrm>
        </p:grpSpPr>
        <p:pic>
          <p:nvPicPr>
            <p:cNvPr id="42" name="Picture 3" descr=""/>
            <p:cNvPicPr/>
            <p:nvPr/>
          </p:nvPicPr>
          <p:blipFill>
            <a:blip r:embed="rId1"/>
            <a:stretch/>
          </p:blipFill>
          <p:spPr>
            <a:xfrm>
              <a:off x="1892160" y="1733040"/>
              <a:ext cx="4121280" cy="704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5"/>
            <p:cNvSpPr/>
            <p:nvPr/>
          </p:nvSpPr>
          <p:spPr>
            <a:xfrm>
              <a:off x="1031760" y="1980720"/>
              <a:ext cx="1015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ff0000"/>
                  </a:solidFill>
                  <a:latin typeface="Calibri"/>
                </a:rPr>
                <a:t>Motif 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Box 6"/>
            <p:cNvSpPr/>
            <p:nvPr/>
          </p:nvSpPr>
          <p:spPr>
            <a:xfrm>
              <a:off x="2923920" y="204840"/>
              <a:ext cx="961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ff"/>
                  </a:solidFill>
                  <a:latin typeface="Calibri"/>
                </a:rPr>
                <a:t>CCT doma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7"/>
            <p:cNvSpPr/>
            <p:nvPr/>
          </p:nvSpPr>
          <p:spPr>
            <a:xfrm>
              <a:off x="1031760" y="3123720"/>
              <a:ext cx="1200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ff0000"/>
                  </a:solidFill>
                  <a:latin typeface="Calibri"/>
                </a:rPr>
                <a:t>Motif 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8"/>
            <p:cNvSpPr/>
            <p:nvPr/>
          </p:nvSpPr>
          <p:spPr>
            <a:xfrm>
              <a:off x="1074600" y="5229360"/>
              <a:ext cx="914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ff0000"/>
                  </a:solidFill>
                  <a:latin typeface="Calibri"/>
                </a:rPr>
                <a:t>Motif 7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7" name="Picture 5" descr=""/>
            <p:cNvPicPr/>
            <p:nvPr/>
          </p:nvPicPr>
          <p:blipFill>
            <a:blip r:embed="rId2"/>
            <a:stretch/>
          </p:blipFill>
          <p:spPr>
            <a:xfrm>
              <a:off x="1950840" y="586440"/>
              <a:ext cx="3535560" cy="609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6" descr=""/>
            <p:cNvPicPr/>
            <p:nvPr/>
          </p:nvPicPr>
          <p:blipFill>
            <a:blip r:embed="rId3"/>
            <a:stretch/>
          </p:blipFill>
          <p:spPr>
            <a:xfrm>
              <a:off x="1885680" y="2971080"/>
              <a:ext cx="4972320" cy="761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Box 11"/>
            <p:cNvSpPr/>
            <p:nvPr/>
          </p:nvSpPr>
          <p:spPr>
            <a:xfrm>
              <a:off x="1031760" y="4170600"/>
              <a:ext cx="838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ff0000"/>
                  </a:solidFill>
                  <a:latin typeface="Calibri"/>
                </a:rPr>
                <a:t>Motif 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Picture 7" descr=""/>
            <p:cNvPicPr/>
            <p:nvPr/>
          </p:nvPicPr>
          <p:blipFill>
            <a:blip r:embed="rId4"/>
            <a:stretch/>
          </p:blipFill>
          <p:spPr>
            <a:xfrm>
              <a:off x="1866600" y="3958200"/>
              <a:ext cx="4991400" cy="822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8" descr=""/>
            <p:cNvPicPr/>
            <p:nvPr/>
          </p:nvPicPr>
          <p:blipFill>
            <a:blip r:embed="rId5"/>
            <a:stretch/>
          </p:blipFill>
          <p:spPr>
            <a:xfrm>
              <a:off x="1981080" y="4989960"/>
              <a:ext cx="3241800" cy="696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Box 14"/>
            <p:cNvSpPr/>
            <p:nvPr/>
          </p:nvSpPr>
          <p:spPr>
            <a:xfrm>
              <a:off x="1031760" y="686160"/>
              <a:ext cx="1166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ff0000"/>
                  </a:solidFill>
                  <a:latin typeface="Calibri"/>
                </a:rPr>
                <a:t>Motif 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15"/>
            <p:cNvSpPr/>
            <p:nvPr/>
          </p:nvSpPr>
          <p:spPr>
            <a:xfrm>
              <a:off x="3047760" y="1370880"/>
              <a:ext cx="1218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ff"/>
                  </a:solidFill>
                  <a:latin typeface="Calibri"/>
                </a:rPr>
                <a:t>Zn finger moti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16"/>
            <p:cNvSpPr/>
            <p:nvPr/>
          </p:nvSpPr>
          <p:spPr>
            <a:xfrm>
              <a:off x="3200400" y="2590200"/>
              <a:ext cx="99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ff"/>
                  </a:solidFill>
                  <a:latin typeface="Calibri"/>
                </a:rPr>
                <a:t>PPD doma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TextBox 17"/>
          <p:cNvSpPr/>
          <p:nvPr/>
        </p:nvSpPr>
        <p:spPr>
          <a:xfrm>
            <a:off x="533520" y="6019920"/>
            <a:ext cx="79246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1│ Protein motifs identified in different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B. rapa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IFY proteins through MEME motif searching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27T23:26:00Z</dcterms:created>
  <dc:creator>Gopal Saha</dc:creator>
  <dc:description/>
  <dc:language>en-US</dc:language>
  <cp:lastModifiedBy>Gopal Saha</cp:lastModifiedBy>
  <dcterms:modified xsi:type="dcterms:W3CDTF">2016-01-31T01:11:49Z</dcterms:modified>
  <cp:revision>2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